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935E632-B8E8-406A-A71F-D7E210ECB3F4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699480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8440" y="5400360"/>
            <a:ext cx="699480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EAF9CFE-B752-4695-AD8D-201B4007D02A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397260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/>
          </p:nvPr>
        </p:nvSpPr>
        <p:spPr>
          <a:xfrm>
            <a:off x="388440" y="540036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9" name="PlaceHolder 5"/>
          <p:cNvSpPr>
            <a:spLocks noGrp="1"/>
          </p:cNvSpPr>
          <p:nvPr>
            <p:ph/>
          </p:nvPr>
        </p:nvSpPr>
        <p:spPr>
          <a:xfrm>
            <a:off x="3972600" y="540036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114DCC9-0240-47C4-9862-7697C7DD812B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2753640" y="235332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5118840" y="235332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388440" y="540036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5" name="PlaceHolder 6"/>
          <p:cNvSpPr>
            <a:spLocks noGrp="1"/>
          </p:cNvSpPr>
          <p:nvPr>
            <p:ph/>
          </p:nvPr>
        </p:nvSpPr>
        <p:spPr>
          <a:xfrm>
            <a:off x="2753640" y="540036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6" name="PlaceHolder 7"/>
          <p:cNvSpPr>
            <a:spLocks noGrp="1"/>
          </p:cNvSpPr>
          <p:nvPr>
            <p:ph/>
          </p:nvPr>
        </p:nvSpPr>
        <p:spPr>
          <a:xfrm>
            <a:off x="5118840" y="540036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EA22A24-B10A-427A-B465-7ED36BA5F67F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ubTitle"/>
          </p:nvPr>
        </p:nvSpPr>
        <p:spPr>
          <a:xfrm>
            <a:off x="388440" y="2353320"/>
            <a:ext cx="699480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085FC9D-5DF7-4B1B-B03D-6984A877D47C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699480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FC78753-58D6-4B63-B604-58E681F5107E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341316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7" name="PlaceHolder 3"/>
          <p:cNvSpPr>
            <a:spLocks noGrp="1"/>
          </p:cNvSpPr>
          <p:nvPr>
            <p:ph/>
          </p:nvPr>
        </p:nvSpPr>
        <p:spPr>
          <a:xfrm>
            <a:off x="3972600" y="2353320"/>
            <a:ext cx="341316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E2A33DF-29CA-4418-871D-9FC30A443912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E2600B1-158B-4D19-B17C-EB65280107A1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subTitle"/>
          </p:nvPr>
        </p:nvSpPr>
        <p:spPr>
          <a:xfrm>
            <a:off x="388440" y="401040"/>
            <a:ext cx="6994800" cy="778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1B090E1-F4BF-4891-9129-4841187FE906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3972600" y="2353320"/>
            <a:ext cx="341316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3" name="PlaceHolder 4"/>
          <p:cNvSpPr>
            <a:spLocks noGrp="1"/>
          </p:cNvSpPr>
          <p:nvPr>
            <p:ph/>
          </p:nvPr>
        </p:nvSpPr>
        <p:spPr>
          <a:xfrm>
            <a:off x="388440" y="540036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43BE4DB-A6BD-4B9D-82B3-70357CA4A60D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341316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7260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972600" y="540036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E4AAC32-6796-4749-9917-FA2034547A3A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7260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8440" y="5400360"/>
            <a:ext cx="699480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E94F49B-61ED-41A2-B032-596D2B418B76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sldNum" idx="1"/>
          </p:nvPr>
        </p:nvSpPr>
        <p:spPr>
          <a:xfrm>
            <a:off x="7100640" y="9589680"/>
            <a:ext cx="282600" cy="2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78787"/>
                </a:solidFill>
                <a:latin typeface="Lucida Grande"/>
                <a:ea typeface="Lucida Grand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A986C8-C9C3-4D51-9083-3A3C015FCC78}" type="slidenum">
              <a:rPr b="0" lang="en-US" sz="1200" spc="-1" strike="noStrike">
                <a:solidFill>
                  <a:srgbClr val="878787"/>
                </a:solidFill>
                <a:latin typeface="Lucida Grande"/>
                <a:ea typeface="Lucida Grande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1"/>
          <p:cNvSpPr/>
          <p:nvPr/>
        </p:nvSpPr>
        <p:spPr>
          <a:xfrm>
            <a:off x="76320" y="0"/>
            <a:ext cx="253980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8160" rIns="38160" tIns="38160" bIns="38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 Bold"/>
                <a:ea typeface="Times New Roman Bold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Gill Sans"/>
            </a:endParaRPr>
          </a:p>
        </p:txBody>
      </p:sp>
      <p:grpSp>
        <p:nvGrpSpPr>
          <p:cNvPr id="38" name="Group 4"/>
          <p:cNvGrpSpPr/>
          <p:nvPr/>
        </p:nvGrpSpPr>
        <p:grpSpPr>
          <a:xfrm>
            <a:off x="434880" y="696960"/>
            <a:ext cx="3298680" cy="2701440"/>
            <a:chOff x="434880" y="696960"/>
            <a:chExt cx="3298680" cy="2701440"/>
          </a:xfrm>
        </p:grpSpPr>
        <p:pic>
          <p:nvPicPr>
            <p:cNvPr id="39" name="Picture 2" descr=""/>
            <p:cNvPicPr/>
            <p:nvPr/>
          </p:nvPicPr>
          <p:blipFill>
            <a:blip r:embed="rId1"/>
            <a:stretch/>
          </p:blipFill>
          <p:spPr>
            <a:xfrm>
              <a:off x="736560" y="1319400"/>
              <a:ext cx="2997000" cy="2079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0" name="Rectangle 3"/>
            <p:cNvSpPr/>
            <p:nvPr/>
          </p:nvSpPr>
          <p:spPr>
            <a:xfrm>
              <a:off x="434880" y="696960"/>
              <a:ext cx="406440" cy="35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8160" rIns="38160" tIns="38160" bIns="381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 Bold"/>
                  <a:ea typeface="Times New Roman Bold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Gill Sans"/>
              </a:endParaRPr>
            </a:p>
          </p:txBody>
        </p:sp>
      </p:grpSp>
      <p:grpSp>
        <p:nvGrpSpPr>
          <p:cNvPr id="41" name="Group 10"/>
          <p:cNvGrpSpPr/>
          <p:nvPr/>
        </p:nvGrpSpPr>
        <p:grpSpPr>
          <a:xfrm>
            <a:off x="4073400" y="671400"/>
            <a:ext cx="2695320" cy="3328560"/>
            <a:chOff x="4073400" y="671400"/>
            <a:chExt cx="2695320" cy="3328560"/>
          </a:xfrm>
        </p:grpSpPr>
        <p:grpSp>
          <p:nvGrpSpPr>
            <p:cNvPr id="42" name="Group 8"/>
            <p:cNvGrpSpPr/>
            <p:nvPr/>
          </p:nvGrpSpPr>
          <p:grpSpPr>
            <a:xfrm>
              <a:off x="4073400" y="671400"/>
              <a:ext cx="2695320" cy="3328560"/>
              <a:chOff x="4073400" y="671400"/>
              <a:chExt cx="2695320" cy="3328560"/>
            </a:xfrm>
          </p:grpSpPr>
          <p:pic>
            <p:nvPicPr>
              <p:cNvPr id="43" name="Picture 5" descr=""/>
              <p:cNvPicPr/>
              <p:nvPr/>
            </p:nvPicPr>
            <p:blipFill>
              <a:blip r:embed="rId2"/>
              <a:stretch/>
            </p:blipFill>
            <p:spPr>
              <a:xfrm rot="16200000">
                <a:off x="4262400" y="1493640"/>
                <a:ext cx="3328560" cy="1683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Rectangle 6"/>
              <p:cNvSpPr/>
              <p:nvPr/>
            </p:nvSpPr>
            <p:spPr>
              <a:xfrm>
                <a:off x="4073400" y="3008880"/>
                <a:ext cx="1245240" cy="292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VE</a:t>
                </a:r>
                <a:endParaRPr b="0" lang="en-US" sz="1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45" name="Rectangle 7"/>
              <p:cNvSpPr/>
              <p:nvPr/>
            </p:nvSpPr>
            <p:spPr>
              <a:xfrm>
                <a:off x="4073400" y="1377720"/>
                <a:ext cx="1245240" cy="292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ntrol</a:t>
                </a:r>
                <a:endParaRPr b="0" lang="en-US" sz="1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sp>
          <p:nvSpPr>
            <p:cNvPr id="46" name="Rectangle 9"/>
            <p:cNvSpPr/>
            <p:nvPr/>
          </p:nvSpPr>
          <p:spPr>
            <a:xfrm>
              <a:off x="4228920" y="690480"/>
              <a:ext cx="406440" cy="355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8160" rIns="38160" tIns="38160" bIns="381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 Bold"/>
                  <a:ea typeface="Times New Roman Bold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Gill Sans"/>
              </a:endParaRPr>
            </a:p>
          </p:txBody>
        </p:sp>
      </p:grpSp>
      <p:grpSp>
        <p:nvGrpSpPr>
          <p:cNvPr id="47" name="Group 32"/>
          <p:cNvGrpSpPr/>
          <p:nvPr/>
        </p:nvGrpSpPr>
        <p:grpSpPr>
          <a:xfrm>
            <a:off x="3240" y="4152960"/>
            <a:ext cx="6882840" cy="3515400"/>
            <a:chOff x="3240" y="4152960"/>
            <a:chExt cx="6882840" cy="3515400"/>
          </a:xfrm>
        </p:grpSpPr>
        <p:grpSp>
          <p:nvGrpSpPr>
            <p:cNvPr id="48" name="Group 30"/>
            <p:cNvGrpSpPr/>
            <p:nvPr/>
          </p:nvGrpSpPr>
          <p:grpSpPr>
            <a:xfrm>
              <a:off x="3240" y="4354200"/>
              <a:ext cx="6882840" cy="3314160"/>
              <a:chOff x="3240" y="4354200"/>
              <a:chExt cx="6882840" cy="3314160"/>
            </a:xfrm>
          </p:grpSpPr>
          <p:pic>
            <p:nvPicPr>
              <p:cNvPr id="49" name="Picture 11" descr=""/>
              <p:cNvPicPr/>
              <p:nvPr/>
            </p:nvPicPr>
            <p:blipFill>
              <a:blip r:embed="rId3">
                <a:grayscl/>
              </a:blip>
              <a:srcRect l="2743" t="18063" r="44100" b="19901"/>
              <a:stretch/>
            </p:blipFill>
            <p:spPr>
              <a:xfrm>
                <a:off x="1050480" y="4619160"/>
                <a:ext cx="1927080" cy="1425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0" name="Picture 12" descr=""/>
              <p:cNvPicPr/>
              <p:nvPr/>
            </p:nvPicPr>
            <p:blipFill>
              <a:blip r:embed="rId4">
                <a:grayscl/>
              </a:blip>
              <a:srcRect l="1937" t="16491" r="47568" b="17151"/>
              <a:stretch/>
            </p:blipFill>
            <p:spPr>
              <a:xfrm>
                <a:off x="1018800" y="6112440"/>
                <a:ext cx="1911240" cy="1555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1" name="Picture 13" descr=""/>
              <p:cNvPicPr/>
              <p:nvPr/>
            </p:nvPicPr>
            <p:blipFill>
              <a:blip r:embed="rId5">
                <a:grayscl/>
              </a:blip>
              <a:srcRect l="1763" t="15383" r="46598" b="20027"/>
              <a:stretch/>
            </p:blipFill>
            <p:spPr>
              <a:xfrm>
                <a:off x="3033360" y="4619160"/>
                <a:ext cx="1815840" cy="1425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" name="Picture 14" descr=""/>
              <p:cNvPicPr/>
              <p:nvPr/>
            </p:nvPicPr>
            <p:blipFill>
              <a:blip r:embed="rId6">
                <a:grayscl/>
              </a:blip>
              <a:srcRect l="2891" t="17080" r="45411" b="19115"/>
              <a:stretch/>
            </p:blipFill>
            <p:spPr>
              <a:xfrm>
                <a:off x="3103200" y="6226560"/>
                <a:ext cx="1827000" cy="1424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" name="Picture 15" descr=""/>
              <p:cNvPicPr/>
              <p:nvPr/>
            </p:nvPicPr>
            <p:blipFill>
              <a:blip r:embed="rId7">
                <a:grayscl/>
              </a:blip>
              <a:srcRect l="1626" t="17104" r="48377" b="21213"/>
              <a:stretch/>
            </p:blipFill>
            <p:spPr>
              <a:xfrm>
                <a:off x="4957560" y="4654080"/>
                <a:ext cx="1879200" cy="1425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4" name="Picture 16" descr=""/>
              <p:cNvPicPr/>
              <p:nvPr/>
            </p:nvPicPr>
            <p:blipFill>
              <a:blip r:embed="rId8">
                <a:grayscl/>
              </a:blip>
              <a:srcRect l="1652" t="17473" r="45934" b="19508"/>
              <a:stretch/>
            </p:blipFill>
            <p:spPr>
              <a:xfrm>
                <a:off x="5014440" y="6242400"/>
                <a:ext cx="1871640" cy="14259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55" name="Group 29"/>
              <p:cNvGrpSpPr/>
              <p:nvPr/>
            </p:nvGrpSpPr>
            <p:grpSpPr>
              <a:xfrm>
                <a:off x="3240" y="4354200"/>
                <a:ext cx="6866640" cy="2584800"/>
                <a:chOff x="3240" y="4354200"/>
                <a:chExt cx="6866640" cy="2584800"/>
              </a:xfrm>
            </p:grpSpPr>
            <p:sp>
              <p:nvSpPr>
                <p:cNvPr id="56" name="Rectangle 17"/>
                <p:cNvSpPr/>
                <p:nvPr/>
              </p:nvSpPr>
              <p:spPr>
                <a:xfrm>
                  <a:off x="1990440" y="6536160"/>
                  <a:ext cx="952200" cy="291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38160" rIns="38160" tIns="38160" bIns="3816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40.71%</a:t>
                  </a:r>
                  <a:endParaRPr b="0" lang="en-US" sz="16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  <p:grpSp>
              <p:nvGrpSpPr>
                <p:cNvPr id="57" name="Group 28"/>
                <p:cNvGrpSpPr/>
                <p:nvPr/>
              </p:nvGrpSpPr>
              <p:grpSpPr>
                <a:xfrm>
                  <a:off x="3240" y="4354200"/>
                  <a:ext cx="6866640" cy="2584800"/>
                  <a:chOff x="3240" y="4354200"/>
                  <a:chExt cx="6866640" cy="2584800"/>
                </a:xfrm>
              </p:grpSpPr>
              <p:sp>
                <p:nvSpPr>
                  <p:cNvPr id="58" name="Rectangle 18"/>
                  <p:cNvSpPr/>
                  <p:nvPr/>
                </p:nvSpPr>
                <p:spPr>
                  <a:xfrm>
                    <a:off x="1952280" y="4990680"/>
                    <a:ext cx="952200" cy="292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38160" rIns="38160" tIns="38160" bIns="38160" anchor="t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41.9%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Gill Sans"/>
                    </a:endParaRPr>
                  </a:p>
                </p:txBody>
              </p:sp>
              <p:sp>
                <p:nvSpPr>
                  <p:cNvPr id="59" name="Rectangle 19"/>
                  <p:cNvSpPr/>
                  <p:nvPr/>
                </p:nvSpPr>
                <p:spPr>
                  <a:xfrm>
                    <a:off x="3498480" y="4354200"/>
                    <a:ext cx="1346040" cy="2919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38160" rIns="38160" tIns="38160" bIns="38160" anchor="t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48 Hours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Gill Sans"/>
                    </a:endParaRPr>
                  </a:p>
                </p:txBody>
              </p:sp>
              <p:sp>
                <p:nvSpPr>
                  <p:cNvPr id="60" name="Rectangle 20"/>
                  <p:cNvSpPr/>
                  <p:nvPr/>
                </p:nvSpPr>
                <p:spPr>
                  <a:xfrm>
                    <a:off x="3240" y="6647040"/>
                    <a:ext cx="1345680" cy="2919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38160" rIns="38160" tIns="38160" bIns="38160" anchor="t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EVE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Gill Sans"/>
                    </a:endParaRPr>
                  </a:p>
                </p:txBody>
              </p:sp>
              <p:sp>
                <p:nvSpPr>
                  <p:cNvPr id="61" name="Rectangle 21"/>
                  <p:cNvSpPr/>
                  <p:nvPr/>
                </p:nvSpPr>
                <p:spPr>
                  <a:xfrm>
                    <a:off x="1528560" y="4354200"/>
                    <a:ext cx="1345680" cy="2919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38160" rIns="38160" tIns="38160" bIns="38160" anchor="t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4 Hours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Gill Sans"/>
                    </a:endParaRPr>
                  </a:p>
                </p:txBody>
              </p:sp>
              <p:sp>
                <p:nvSpPr>
                  <p:cNvPr id="62" name="Rectangle 22"/>
                  <p:cNvSpPr/>
                  <p:nvPr/>
                </p:nvSpPr>
                <p:spPr>
                  <a:xfrm>
                    <a:off x="5489280" y="4354200"/>
                    <a:ext cx="1345680" cy="2919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38160" rIns="38160" tIns="38160" bIns="38160" anchor="t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72 Hours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Gill Sans"/>
                    </a:endParaRPr>
                  </a:p>
                </p:txBody>
              </p:sp>
              <p:sp>
                <p:nvSpPr>
                  <p:cNvPr id="63" name="Rectangle 23"/>
                  <p:cNvSpPr/>
                  <p:nvPr/>
                </p:nvSpPr>
                <p:spPr>
                  <a:xfrm>
                    <a:off x="3240" y="4978080"/>
                    <a:ext cx="1345680" cy="2919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38160" rIns="38160" tIns="38160" bIns="38160" anchor="t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ontrol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Gill Sans"/>
                    </a:endParaRPr>
                  </a:p>
                </p:txBody>
              </p:sp>
              <p:sp>
                <p:nvSpPr>
                  <p:cNvPr id="64" name="Rectangle 24"/>
                  <p:cNvSpPr/>
                  <p:nvPr/>
                </p:nvSpPr>
                <p:spPr>
                  <a:xfrm>
                    <a:off x="3889080" y="4978080"/>
                    <a:ext cx="952200" cy="2919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38160" rIns="38160" tIns="38160" bIns="38160" anchor="t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60.08%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Gill Sans"/>
                    </a:endParaRPr>
                  </a:p>
                </p:txBody>
              </p:sp>
              <p:sp>
                <p:nvSpPr>
                  <p:cNvPr id="65" name="Rectangle 25"/>
                  <p:cNvSpPr/>
                  <p:nvPr/>
                </p:nvSpPr>
                <p:spPr>
                  <a:xfrm>
                    <a:off x="3930480" y="6542280"/>
                    <a:ext cx="951840" cy="2919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38160" rIns="38160" tIns="38160" bIns="38160" anchor="t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44.32%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Gill Sans"/>
                    </a:endParaRPr>
                  </a:p>
                </p:txBody>
              </p:sp>
              <p:sp>
                <p:nvSpPr>
                  <p:cNvPr id="66" name="Rectangle 26"/>
                  <p:cNvSpPr/>
                  <p:nvPr/>
                </p:nvSpPr>
                <p:spPr>
                  <a:xfrm>
                    <a:off x="5918040" y="6575400"/>
                    <a:ext cx="951840" cy="292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38160" rIns="38160" tIns="38160" bIns="38160" anchor="t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54.01%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Gill Sans"/>
                    </a:endParaRPr>
                  </a:p>
                </p:txBody>
              </p:sp>
              <p:sp>
                <p:nvSpPr>
                  <p:cNvPr id="67" name="Rectangle 27"/>
                  <p:cNvSpPr/>
                  <p:nvPr/>
                </p:nvSpPr>
                <p:spPr>
                  <a:xfrm>
                    <a:off x="5870160" y="4990680"/>
                    <a:ext cx="952200" cy="292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38160" rIns="38160" tIns="38160" bIns="38160" anchor="t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66.63%</a:t>
                    </a:r>
                    <a:endParaRPr b="0" lang="en-US" sz="1600" spc="-1" strike="noStrike">
                      <a:solidFill>
                        <a:srgbClr val="000000"/>
                      </a:solidFill>
                      <a:latin typeface="Gill Sans"/>
                    </a:endParaRPr>
                  </a:p>
                </p:txBody>
              </p:sp>
            </p:grpSp>
          </p:grpSp>
        </p:grpSp>
        <p:sp>
          <p:nvSpPr>
            <p:cNvPr id="68" name="Rectangle 31"/>
            <p:cNvSpPr/>
            <p:nvPr/>
          </p:nvSpPr>
          <p:spPr>
            <a:xfrm>
              <a:off x="412560" y="4152960"/>
              <a:ext cx="406080" cy="35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8160" rIns="38160" tIns="38160" bIns="381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 Bold"/>
                  <a:ea typeface="Times New Roman Bold"/>
                </a:rPr>
                <a:t>C</a:t>
              </a:r>
              <a:endParaRPr b="0" lang="en-US" sz="2000" spc="-1" strike="noStrike">
                <a:solidFill>
                  <a:srgbClr val="000000"/>
                </a:solidFill>
                <a:latin typeface="Gill Sans"/>
              </a:endParaRPr>
            </a:p>
          </p:txBody>
        </p:sp>
      </p:grpSp>
      <p:sp>
        <p:nvSpPr>
          <p:cNvPr id="69" name="Rectangle 33"/>
          <p:cNvSpPr/>
          <p:nvPr/>
        </p:nvSpPr>
        <p:spPr>
          <a:xfrm>
            <a:off x="152280" y="7823160"/>
            <a:ext cx="7226280" cy="151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just">
              <a:lnSpc>
                <a:spcPct val="110000"/>
              </a:lnSpc>
              <a:spcBef>
                <a:spcPts val="11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 Bold"/>
                <a:ea typeface="Times New Roman Bold"/>
              </a:rPr>
              <a:t>Supplemental Fig. 1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verolimus does not impact the proliferation or cycling of normal breast cells</a:t>
            </a:r>
            <a:endParaRPr b="0" lang="en-US" sz="1200" spc="-1" strike="noStrike">
              <a:solidFill>
                <a:srgbClr val="000000"/>
              </a:solidFill>
              <a:latin typeface="Gill Sans"/>
            </a:endParaRPr>
          </a:p>
          <a:p>
            <a:pPr algn="just"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 Bold"/>
                <a:ea typeface="Times New Roman Bold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CF10A cells were seeded in 24-well plates and treated with a range of everolimus doses. The percentage of viable cells was determined after 72 hours of everolimus treatment. </a:t>
            </a:r>
            <a:r>
              <a:rPr b="0" lang="en-US" sz="1200" spc="-1" strike="noStrike">
                <a:solidFill>
                  <a:srgbClr val="000000"/>
                </a:solidFill>
                <a:latin typeface="Times New Roman Bold"/>
                <a:ea typeface="Times New Roman Bold"/>
              </a:rPr>
              <a:t>b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CF10A cells were seeded in 6-well plates in single cell suspension and treated with 20 nM everolimus for 9 days. The number and size of clones was quantified and represents means from two independent experiments conducted in triplicate. </a:t>
            </a:r>
            <a:r>
              <a:rPr b="0" lang="en-US" sz="1200" spc="-1" strike="noStrike">
                <a:solidFill>
                  <a:srgbClr val="000000"/>
                </a:solidFill>
                <a:latin typeface="Times New Roman Bold"/>
                <a:ea typeface="Times New Roman Bold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fter 24, 48 and 72 hours of 20 nM everolimus treatment in 6-well plates, MCF10A cells were subjected to cell cycle analysis. The percent of cells in G1 phase is highlighted.</a:t>
            </a:r>
            <a:endParaRPr b="0" lang="en-US" sz="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sona Lui</dc:creator>
  <dc:description/>
  <dc:language>en-US</dc:language>
  <cp:lastModifiedBy>Asona Lui</cp:lastModifiedBy>
  <dcterms:modified xsi:type="dcterms:W3CDTF">2016-02-16T17:28:46Z</dcterms:modified>
  <cp:revision>1</cp:revision>
  <dc:subject/>
  <dc:title>PowerPoint Presentation</dc:title>
</cp:coreProperties>
</file>